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450" r:id="rId2"/>
    <p:sldId id="451" r:id="rId3"/>
    <p:sldId id="449" r:id="rId4"/>
  </p:sldIdLst>
  <p:sldSz cx="6264275" cy="8421688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turi Dasgupta" initials="KD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66"/>
    <a:srgbClr val="D0EBB3"/>
    <a:srgbClr val="FF99FF"/>
    <a:srgbClr val="FF6600"/>
    <a:srgbClr val="FF66CC"/>
    <a:srgbClr val="7C0E11"/>
    <a:srgbClr val="CC00CC"/>
    <a:srgbClr val="FF3399"/>
    <a:srgbClr val="FF5050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166" autoAdjust="0"/>
    <p:restoredTop sz="96405" autoAdjust="0"/>
  </p:normalViewPr>
  <p:slideViewPr>
    <p:cSldViewPr>
      <p:cViewPr varScale="1">
        <p:scale>
          <a:sx n="104" d="100"/>
          <a:sy n="104" d="100"/>
        </p:scale>
        <p:origin x="3512" y="208"/>
      </p:cViewPr>
      <p:guideLst>
        <p:guide orient="horz" pos="2653"/>
        <p:guide pos="197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843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54238" y="685800"/>
            <a:ext cx="2549525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36CED8E8-F137-4E73-9AD7-23FE4FCFC60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9925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3"/>
            <a:ext cx="5324634" cy="18052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/>
            </a:lvl1pPr>
            <a:lvl2pPr marL="313228" indent="0" algn="ctr">
              <a:buNone/>
              <a:defRPr/>
            </a:lvl2pPr>
            <a:lvl3pPr marL="626455" indent="0" algn="ctr">
              <a:buNone/>
              <a:defRPr/>
            </a:lvl3pPr>
            <a:lvl4pPr marL="939683" indent="0" algn="ctr">
              <a:buNone/>
              <a:defRPr/>
            </a:lvl4pPr>
            <a:lvl5pPr marL="1252911" indent="0" algn="ctr">
              <a:buNone/>
              <a:defRPr/>
            </a:lvl5pPr>
            <a:lvl6pPr marL="1566139" indent="0" algn="ctr">
              <a:buNone/>
              <a:defRPr/>
            </a:lvl6pPr>
            <a:lvl7pPr marL="1879366" indent="0" algn="ctr">
              <a:buNone/>
              <a:defRPr/>
            </a:lvl7pPr>
            <a:lvl8pPr marL="2192594" indent="0" algn="ctr">
              <a:buNone/>
              <a:defRPr/>
            </a:lvl8pPr>
            <a:lvl9pPr marL="2505822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A1C836-FEAA-4328-83B6-58AEE6B47C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ED3321-3BED-42F2-BC36-F92A276C45B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41599" y="337259"/>
            <a:ext cx="1409462" cy="71857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3214" y="337259"/>
            <a:ext cx="4123981" cy="71857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2F6389-D760-4E5D-BC4A-455534D19AD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264A87-A24C-4273-8D2A-B7B27C6FF2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4" y="5411715"/>
            <a:ext cx="5324634" cy="1672641"/>
          </a:xfrm>
        </p:spPr>
        <p:txBody>
          <a:bodyPr anchor="t"/>
          <a:lstStyle>
            <a:lvl1pPr algn="l">
              <a:defRPr sz="274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4" y="3569471"/>
            <a:ext cx="5324634" cy="1842244"/>
          </a:xfrm>
        </p:spPr>
        <p:txBody>
          <a:bodyPr anchor="b"/>
          <a:lstStyle>
            <a:lvl1pPr marL="0" indent="0">
              <a:buNone/>
              <a:defRPr sz="1370"/>
            </a:lvl1pPr>
            <a:lvl2pPr marL="313228" indent="0">
              <a:buNone/>
              <a:defRPr sz="1233"/>
            </a:lvl2pPr>
            <a:lvl3pPr marL="626455" indent="0">
              <a:buNone/>
              <a:defRPr sz="1096"/>
            </a:lvl3pPr>
            <a:lvl4pPr marL="939683" indent="0">
              <a:buNone/>
              <a:defRPr sz="959"/>
            </a:lvl4pPr>
            <a:lvl5pPr marL="1252911" indent="0">
              <a:buNone/>
              <a:defRPr sz="959"/>
            </a:lvl5pPr>
            <a:lvl6pPr marL="1566139" indent="0">
              <a:buNone/>
              <a:defRPr sz="959"/>
            </a:lvl6pPr>
            <a:lvl7pPr marL="1879366" indent="0">
              <a:buNone/>
              <a:defRPr sz="959"/>
            </a:lvl7pPr>
            <a:lvl8pPr marL="2192594" indent="0">
              <a:buNone/>
              <a:defRPr sz="959"/>
            </a:lvl8pPr>
            <a:lvl9pPr marL="2505822" indent="0">
              <a:buNone/>
              <a:defRPr sz="95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4B0689-EDCB-414C-B7F2-D76726E130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3214" y="1965061"/>
            <a:ext cx="2766721" cy="5557925"/>
          </a:xfrm>
        </p:spPr>
        <p:txBody>
          <a:bodyPr/>
          <a:lstStyle>
            <a:lvl1pPr>
              <a:defRPr sz="1918"/>
            </a:lvl1pPr>
            <a:lvl2pPr>
              <a:defRPr sz="1644"/>
            </a:lvl2pPr>
            <a:lvl3pPr>
              <a:defRPr sz="1370"/>
            </a:lvl3pPr>
            <a:lvl4pPr>
              <a:defRPr sz="1233"/>
            </a:lvl4pPr>
            <a:lvl5pPr>
              <a:defRPr sz="1233"/>
            </a:lvl5pPr>
            <a:lvl6pPr>
              <a:defRPr sz="1233"/>
            </a:lvl6pPr>
            <a:lvl7pPr>
              <a:defRPr sz="1233"/>
            </a:lvl7pPr>
            <a:lvl8pPr>
              <a:defRPr sz="1233"/>
            </a:lvl8pPr>
            <a:lvl9pPr>
              <a:defRPr sz="12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4340" y="1965061"/>
            <a:ext cx="2766721" cy="5557925"/>
          </a:xfrm>
        </p:spPr>
        <p:txBody>
          <a:bodyPr/>
          <a:lstStyle>
            <a:lvl1pPr>
              <a:defRPr sz="1918"/>
            </a:lvl1pPr>
            <a:lvl2pPr>
              <a:defRPr sz="1644"/>
            </a:lvl2pPr>
            <a:lvl3pPr>
              <a:defRPr sz="1370"/>
            </a:lvl3pPr>
            <a:lvl4pPr>
              <a:defRPr sz="1233"/>
            </a:lvl4pPr>
            <a:lvl5pPr>
              <a:defRPr sz="1233"/>
            </a:lvl5pPr>
            <a:lvl6pPr>
              <a:defRPr sz="1233"/>
            </a:lvl6pPr>
            <a:lvl7pPr>
              <a:defRPr sz="1233"/>
            </a:lvl7pPr>
            <a:lvl8pPr>
              <a:defRPr sz="1233"/>
            </a:lvl8pPr>
            <a:lvl9pPr>
              <a:defRPr sz="12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F2646C-AE7C-4505-A392-F6DFDD4DC10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7"/>
            <a:ext cx="2767809" cy="4852219"/>
          </a:xfrm>
        </p:spPr>
        <p:txBody>
          <a:bodyPr/>
          <a:lstStyle>
            <a:lvl1pPr>
              <a:defRPr sz="1644"/>
            </a:lvl1pPr>
            <a:lvl2pPr>
              <a:defRPr sz="1370"/>
            </a:lvl2pPr>
            <a:lvl3pPr>
              <a:defRPr sz="1233"/>
            </a:lvl3pPr>
            <a:lvl4pPr>
              <a:defRPr sz="1096"/>
            </a:lvl4pPr>
            <a:lvl5pPr>
              <a:defRPr sz="1096"/>
            </a:lvl5pPr>
            <a:lvl6pPr>
              <a:defRPr sz="1096"/>
            </a:lvl6pPr>
            <a:lvl7pPr>
              <a:defRPr sz="1096"/>
            </a:lvl7pPr>
            <a:lvl8pPr>
              <a:defRPr sz="1096"/>
            </a:lvl8pPr>
            <a:lvl9pPr>
              <a:defRPr sz="10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5" y="1885133"/>
            <a:ext cx="2768897" cy="7856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5" y="2670767"/>
            <a:ext cx="2768897" cy="4852219"/>
          </a:xfrm>
        </p:spPr>
        <p:txBody>
          <a:bodyPr/>
          <a:lstStyle>
            <a:lvl1pPr>
              <a:defRPr sz="1644"/>
            </a:lvl1pPr>
            <a:lvl2pPr>
              <a:defRPr sz="1370"/>
            </a:lvl2pPr>
            <a:lvl3pPr>
              <a:defRPr sz="1233"/>
            </a:lvl3pPr>
            <a:lvl4pPr>
              <a:defRPr sz="1096"/>
            </a:lvl4pPr>
            <a:lvl5pPr>
              <a:defRPr sz="1096"/>
            </a:lvl5pPr>
            <a:lvl6pPr>
              <a:defRPr sz="1096"/>
            </a:lvl6pPr>
            <a:lvl7pPr>
              <a:defRPr sz="1096"/>
            </a:lvl7pPr>
            <a:lvl8pPr>
              <a:defRPr sz="1096"/>
            </a:lvl8pPr>
            <a:lvl9pPr>
              <a:defRPr sz="10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4590FB-787C-404F-9469-38E36DBB24D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B45914-49D0-4830-B7E7-2C18F677A5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5180D1-F494-4DC6-9C59-4BB7353FEC7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3" cy="1427008"/>
          </a:xfrm>
        </p:spPr>
        <p:txBody>
          <a:bodyPr anchor="b"/>
          <a:lstStyle>
            <a:lvl1pPr algn="l">
              <a:defRPr sz="137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7" y="335309"/>
            <a:ext cx="3501904" cy="7187677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3" cy="5760669"/>
          </a:xfrm>
        </p:spPr>
        <p:txBody>
          <a:bodyPr/>
          <a:lstStyle>
            <a:lvl1pPr marL="0" indent="0">
              <a:buNone/>
              <a:defRPr sz="959"/>
            </a:lvl1pPr>
            <a:lvl2pPr marL="313228" indent="0">
              <a:buNone/>
              <a:defRPr sz="822"/>
            </a:lvl2pPr>
            <a:lvl3pPr marL="626455" indent="0">
              <a:buNone/>
              <a:defRPr sz="685"/>
            </a:lvl3pPr>
            <a:lvl4pPr marL="939683" indent="0">
              <a:buNone/>
              <a:defRPr sz="617"/>
            </a:lvl4pPr>
            <a:lvl5pPr marL="1252911" indent="0">
              <a:buNone/>
              <a:defRPr sz="617"/>
            </a:lvl5pPr>
            <a:lvl6pPr marL="1566139" indent="0">
              <a:buNone/>
              <a:defRPr sz="617"/>
            </a:lvl6pPr>
            <a:lvl7pPr marL="1879366" indent="0">
              <a:buNone/>
              <a:defRPr sz="617"/>
            </a:lvl7pPr>
            <a:lvl8pPr marL="2192594" indent="0">
              <a:buNone/>
              <a:defRPr sz="617"/>
            </a:lvl8pPr>
            <a:lvl9pPr marL="2505822" indent="0">
              <a:buNone/>
              <a:defRPr sz="61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3E7E74-5BED-46F2-9755-BC9DEA2485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1"/>
            <a:ext cx="3758565" cy="695960"/>
          </a:xfrm>
        </p:spPr>
        <p:txBody>
          <a:bodyPr anchor="b"/>
          <a:lstStyle>
            <a:lvl1pPr algn="l">
              <a:defRPr sz="137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1"/>
            <a:ext cx="3758565" cy="988378"/>
          </a:xfrm>
        </p:spPr>
        <p:txBody>
          <a:bodyPr/>
          <a:lstStyle>
            <a:lvl1pPr marL="0" indent="0">
              <a:buNone/>
              <a:defRPr sz="959"/>
            </a:lvl1pPr>
            <a:lvl2pPr marL="313228" indent="0">
              <a:buNone/>
              <a:defRPr sz="822"/>
            </a:lvl2pPr>
            <a:lvl3pPr marL="626455" indent="0">
              <a:buNone/>
              <a:defRPr sz="685"/>
            </a:lvl3pPr>
            <a:lvl4pPr marL="939683" indent="0">
              <a:buNone/>
              <a:defRPr sz="617"/>
            </a:lvl4pPr>
            <a:lvl5pPr marL="1252911" indent="0">
              <a:buNone/>
              <a:defRPr sz="617"/>
            </a:lvl5pPr>
            <a:lvl6pPr marL="1566139" indent="0">
              <a:buNone/>
              <a:defRPr sz="617"/>
            </a:lvl6pPr>
            <a:lvl7pPr marL="1879366" indent="0">
              <a:buNone/>
              <a:defRPr sz="617"/>
            </a:lvl7pPr>
            <a:lvl8pPr marL="2192594" indent="0">
              <a:buNone/>
              <a:defRPr sz="617"/>
            </a:lvl8pPr>
            <a:lvl9pPr marL="2505822" indent="0">
              <a:buNone/>
              <a:defRPr sz="61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754592-2CBE-4E2A-93C3-165D7F72F8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13214" y="337258"/>
            <a:ext cx="5637848" cy="14036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13214" y="1965061"/>
            <a:ext cx="5637848" cy="5557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13214" y="7669195"/>
            <a:ext cx="1461664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959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140294" y="7669195"/>
            <a:ext cx="1983687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959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489397" y="7669195"/>
            <a:ext cx="1461664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59"/>
            </a:lvl1pPr>
          </a:lstStyle>
          <a:p>
            <a:pPr>
              <a:defRPr/>
            </a:pPr>
            <a:fld id="{F6F8016A-C16B-4FB4-8698-94ADC36A62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5pPr>
      <a:lvl6pPr marL="313228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6pPr>
      <a:lvl7pPr marL="626455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7pPr>
      <a:lvl8pPr marL="939683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8pPr>
      <a:lvl9pPr marL="1252911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234921" indent="-234921" algn="l" rtl="0" eaLnBrk="0" fontAlgn="base" hangingPunct="0">
        <a:spcBef>
          <a:spcPct val="20000"/>
        </a:spcBef>
        <a:spcAft>
          <a:spcPct val="0"/>
        </a:spcAft>
        <a:buChar char="•"/>
        <a:defRPr sz="2192">
          <a:solidFill>
            <a:schemeClr val="tx1"/>
          </a:solidFill>
          <a:latin typeface="+mn-lt"/>
          <a:ea typeface="+mn-ea"/>
          <a:cs typeface="+mn-cs"/>
        </a:defRPr>
      </a:lvl1pPr>
      <a:lvl2pPr marL="508995" indent="-195767" algn="l" rtl="0" eaLnBrk="0" fontAlgn="base" hangingPunct="0">
        <a:spcBef>
          <a:spcPct val="20000"/>
        </a:spcBef>
        <a:spcAft>
          <a:spcPct val="0"/>
        </a:spcAft>
        <a:buChar char="–"/>
        <a:defRPr sz="1918">
          <a:solidFill>
            <a:schemeClr val="tx1"/>
          </a:solidFill>
          <a:latin typeface="+mn-lt"/>
          <a:cs typeface="+mn-cs"/>
        </a:defRPr>
      </a:lvl2pPr>
      <a:lvl3pPr marL="783069" indent="-156614" algn="l" rtl="0" eaLnBrk="0" fontAlgn="base" hangingPunct="0">
        <a:spcBef>
          <a:spcPct val="20000"/>
        </a:spcBef>
        <a:spcAft>
          <a:spcPct val="0"/>
        </a:spcAft>
        <a:buChar char="•"/>
        <a:defRPr sz="1644">
          <a:solidFill>
            <a:schemeClr val="tx1"/>
          </a:solidFill>
          <a:latin typeface="+mn-lt"/>
          <a:cs typeface="+mn-cs"/>
        </a:defRPr>
      </a:lvl3pPr>
      <a:lvl4pPr marL="1096297" indent="-156614" algn="l" rtl="0" eaLnBrk="0" fontAlgn="base" hangingPunct="0">
        <a:spcBef>
          <a:spcPct val="20000"/>
        </a:spcBef>
        <a:spcAft>
          <a:spcPct val="0"/>
        </a:spcAft>
        <a:buChar char="–"/>
        <a:defRPr sz="1370">
          <a:solidFill>
            <a:schemeClr val="tx1"/>
          </a:solidFill>
          <a:latin typeface="+mn-lt"/>
          <a:cs typeface="+mn-cs"/>
        </a:defRPr>
      </a:lvl4pPr>
      <a:lvl5pPr marL="1409525" indent="-156614" algn="l" rtl="0" eaLnBrk="0" fontAlgn="base" hangingPunct="0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5pPr>
      <a:lvl6pPr marL="1722752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6pPr>
      <a:lvl7pPr marL="2035980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7pPr>
      <a:lvl8pPr marL="2349208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8pPr>
      <a:lvl9pPr marL="2662436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EA0146D-076E-EF4D-B813-68B26CA52795}"/>
              </a:ext>
            </a:extLst>
          </p:cNvPr>
          <p:cNvSpPr/>
          <p:nvPr/>
        </p:nvSpPr>
        <p:spPr>
          <a:xfrm>
            <a:off x="490831" y="123845"/>
            <a:ext cx="53721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" pitchFamily="2" charset="0"/>
                <a:cs typeface="Times New Roman" panose="02020603050405020304" pitchFamily="18" charset="0"/>
              </a:rPr>
              <a:t>Additional file 2: Table S1. </a:t>
            </a:r>
            <a:r>
              <a:rPr lang="en-US" altLang="en-US" sz="1200" b="1" dirty="0">
                <a:latin typeface="Times" pitchFamily="2" charset="0"/>
                <a:ea typeface="Times New Roman" panose="02020603050405020304" pitchFamily="18" charset="0"/>
              </a:rPr>
              <a:t>Transgene copy number measurements in T</a:t>
            </a:r>
            <a:r>
              <a:rPr lang="en-US" altLang="en-US" sz="1200" b="1" baseline="-30000" dirty="0">
                <a:latin typeface="Times" pitchFamily="2" charset="0"/>
                <a:ea typeface="Times New Roman" panose="02020603050405020304" pitchFamily="18" charset="0"/>
              </a:rPr>
              <a:t>1</a:t>
            </a:r>
            <a:r>
              <a:rPr lang="en-US" altLang="en-US" sz="1200" b="1" dirty="0">
                <a:latin typeface="Times" pitchFamily="2" charset="0"/>
                <a:ea typeface="Times New Roman" panose="02020603050405020304" pitchFamily="18" charset="0"/>
              </a:rPr>
              <a:t> sibling transgenic Micro-Tom tomato lines from 3 independent events (4 plants from each family).</a:t>
            </a:r>
            <a:endParaRPr lang="en-US" sz="1200" b="1" dirty="0">
              <a:latin typeface="Times" pitchFamily="2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BD592CC-2C70-5345-A928-6B604E2878D2}"/>
              </a:ext>
            </a:extLst>
          </p:cNvPr>
          <p:cNvSpPr/>
          <p:nvPr/>
        </p:nvSpPr>
        <p:spPr>
          <a:xfrm>
            <a:off x="357482" y="7743845"/>
            <a:ext cx="563879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indent="11113" eaLnBrk="0" hangingPunct="0"/>
            <a:r>
              <a:rPr lang="en-US" altLang="en-US" sz="1000" baseline="30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altLang="en-US" sz="1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lang="en-US" altLang="en-US" sz="1000" dirty="0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en-US" sz="1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ddPCR</a:t>
            </a:r>
            <a:r>
              <a:rPr lang="en-US" altLang="en-US" sz="1000" dirty="0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 (droplet digital polymerase chain reaction) copy number and error (maximum and minimum Poisson distribution for the 95% confidence interval) calculated using </a:t>
            </a:r>
            <a:r>
              <a:rPr lang="en-US" altLang="en-US" sz="1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QuantaSoft</a:t>
            </a:r>
            <a:r>
              <a:rPr lang="en-US" altLang="en-US" sz="1000" baseline="30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TM</a:t>
            </a:r>
            <a:r>
              <a:rPr lang="en-US" altLang="en-US" sz="1000" dirty="0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 software (v1.6.6.0320). </a:t>
            </a:r>
            <a:endParaRPr lang="en-US" altLang="en-US" sz="1000" dirty="0">
              <a:latin typeface="Times" pitchFamily="2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BC4C7F64-66AD-8649-8BB3-5FD38A52E7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0520936"/>
              </p:ext>
            </p:extLst>
          </p:nvPr>
        </p:nvGraphicFramePr>
        <p:xfrm>
          <a:off x="350837" y="885845"/>
          <a:ext cx="5562600" cy="6858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82233">
                  <a:extLst>
                    <a:ext uri="{9D8B030D-6E8A-4147-A177-3AD203B41FA5}">
                      <a16:colId xmlns:a16="http://schemas.microsoft.com/office/drawing/2014/main" val="1280105822"/>
                    </a:ext>
                  </a:extLst>
                </a:gridCol>
                <a:gridCol w="1594884">
                  <a:extLst>
                    <a:ext uri="{9D8B030D-6E8A-4147-A177-3AD203B41FA5}">
                      <a16:colId xmlns:a16="http://schemas.microsoft.com/office/drawing/2014/main" val="2134023344"/>
                    </a:ext>
                  </a:extLst>
                </a:gridCol>
                <a:gridCol w="1116418">
                  <a:extLst>
                    <a:ext uri="{9D8B030D-6E8A-4147-A177-3AD203B41FA5}">
                      <a16:colId xmlns:a16="http://schemas.microsoft.com/office/drawing/2014/main" val="256194836"/>
                    </a:ext>
                  </a:extLst>
                </a:gridCol>
                <a:gridCol w="1469065">
                  <a:extLst>
                    <a:ext uri="{9D8B030D-6E8A-4147-A177-3AD203B41FA5}">
                      <a16:colId xmlns:a16="http://schemas.microsoft.com/office/drawing/2014/main" val="3068592677"/>
                    </a:ext>
                  </a:extLst>
                </a:gridCol>
              </a:tblGrid>
              <a:tr h="42535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35433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35433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Line number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indent="-17145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17145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ddPCR nptII copy #</a:t>
                      </a:r>
                      <a:r>
                        <a:rPr lang="en-US" sz="10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66675" indent="-11430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66675" indent="-11430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66675" indent="-11430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  Line number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indent="-1257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 </a:t>
                      </a:r>
                    </a:p>
                    <a:p>
                      <a:pPr marL="0" marR="0" indent="-1257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1257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 ddPCR nptII copy #</a:t>
                      </a:r>
                      <a:r>
                        <a:rPr lang="en-US" sz="10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703181001"/>
                  </a:ext>
                </a:extLst>
              </a:tr>
              <a:tr h="16492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4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4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4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4-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8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8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8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8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10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10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10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SEPp-10-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7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0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4.98± 0.1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5.05± 0.18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2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0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3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0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4± 0.0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1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1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1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1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3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3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3-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3-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5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5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5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WAXp-5-9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.00± 0.1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96± 0.1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86± 0.09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5.91± 0.2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92± 0.1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5.81± 0.2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90± 0.09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94± 0.10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6.00± 0.2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.05± 0.1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4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82± 0.1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182271564"/>
                  </a:ext>
                </a:extLst>
              </a:tr>
              <a:tr h="13744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3156642800"/>
                  </a:ext>
                </a:extLst>
              </a:tr>
              <a:tr h="16492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2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2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2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2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3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3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3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3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4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4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4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UNKp-4-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8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8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4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3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7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9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± 0.0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2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2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2-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2-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2-8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2-9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4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4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5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5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5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JuSacp-5-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51± 0.0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8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51± 0.0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7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4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50± 0.0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52± 0.0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53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49± 0.0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51± 0.0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022650560"/>
                  </a:ext>
                </a:extLst>
              </a:tr>
              <a:tr h="1374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447295278"/>
                  </a:ext>
                </a:extLst>
              </a:tr>
              <a:tr h="16492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1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1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1-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1-8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6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6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6-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6-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9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9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9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tVO1p-9-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6 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0 ± 0.1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8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0 ± 0.09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0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2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0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5 ± 0.1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1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1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1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1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2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2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2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2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9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9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9-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mMybAp-9-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8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1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1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7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4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9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6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8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2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9 ± 0.0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509695753"/>
                  </a:ext>
                </a:extLst>
              </a:tr>
              <a:tr h="1374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3793289295"/>
                  </a:ext>
                </a:extLst>
              </a:tr>
              <a:tr h="137440">
                <a:tc>
                  <a:txBody>
                    <a:bodyPr/>
                    <a:lstStyle/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171783215"/>
                  </a:ext>
                </a:extLst>
              </a:tr>
              <a:tr h="57019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829924016"/>
                  </a:ext>
                </a:extLst>
              </a:tr>
              <a:tr h="57019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5358703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118267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EA0146D-076E-EF4D-B813-68B26CA52795}"/>
              </a:ext>
            </a:extLst>
          </p:cNvPr>
          <p:cNvSpPr/>
          <p:nvPr/>
        </p:nvSpPr>
        <p:spPr>
          <a:xfrm>
            <a:off x="388937" y="392538"/>
            <a:ext cx="5486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" pitchFamily="2" charset="0"/>
                <a:cs typeface="Times New Roman" panose="02020603050405020304" pitchFamily="18" charset="0"/>
              </a:rPr>
              <a:t>Additional file 2: Table S1 continued.</a:t>
            </a:r>
            <a:r>
              <a:rPr lang="en-US" sz="1200" dirty="0">
                <a:latin typeface="Times" pitchFamily="2" charset="0"/>
              </a:rPr>
              <a:t> </a:t>
            </a:r>
            <a:r>
              <a:rPr lang="en-US" altLang="en-US" sz="1200" b="1" dirty="0">
                <a:latin typeface="Times" pitchFamily="2" charset="0"/>
                <a:ea typeface="Times New Roman" panose="02020603050405020304" pitchFamily="18" charset="0"/>
              </a:rPr>
              <a:t>Transgene copy number measurements in T</a:t>
            </a:r>
            <a:r>
              <a:rPr lang="en-US" altLang="en-US" sz="1200" b="1" baseline="-30000" dirty="0">
                <a:latin typeface="Times" pitchFamily="2" charset="0"/>
                <a:ea typeface="Times New Roman" panose="02020603050405020304" pitchFamily="18" charset="0"/>
              </a:rPr>
              <a:t>1</a:t>
            </a:r>
            <a:r>
              <a:rPr lang="en-US" altLang="en-US" sz="1200" b="1" dirty="0">
                <a:latin typeface="Times" pitchFamily="2" charset="0"/>
                <a:ea typeface="Times New Roman" panose="02020603050405020304" pitchFamily="18" charset="0"/>
              </a:rPr>
              <a:t> sibling transgenic Micro-Tom tomato lines from 3 independent events (4 plants from each family).</a:t>
            </a:r>
            <a:endParaRPr lang="en-US" sz="1200" b="1" dirty="0">
              <a:latin typeface="Times" pitchFamily="2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BD592CC-2C70-5345-A928-6B604E2878D2}"/>
              </a:ext>
            </a:extLst>
          </p:cNvPr>
          <p:cNvSpPr/>
          <p:nvPr/>
        </p:nvSpPr>
        <p:spPr>
          <a:xfrm>
            <a:off x="388937" y="6573044"/>
            <a:ext cx="563879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indent="11113" eaLnBrk="0" hangingPunct="0"/>
            <a:r>
              <a:rPr lang="en-US" altLang="en-US" sz="1000" baseline="30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altLang="en-US" sz="1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lang="en-US" altLang="en-US" sz="1000" dirty="0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en-US" sz="1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ddPCR</a:t>
            </a:r>
            <a:r>
              <a:rPr lang="en-US" altLang="en-US" sz="1000" dirty="0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 (droplet digital polymerase chain reaction) copy number and error (maximum and minimum Poisson distribution for the 95% confidence interval) calculated using </a:t>
            </a:r>
            <a:r>
              <a:rPr lang="en-US" altLang="en-US" sz="1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QuantaSoft</a:t>
            </a:r>
            <a:r>
              <a:rPr lang="en-US" altLang="en-US" sz="1000" baseline="30000" dirty="0" err="1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TM</a:t>
            </a:r>
            <a:r>
              <a:rPr lang="en-US" altLang="en-US" sz="1000" dirty="0">
                <a:latin typeface="Times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 software (v1.6.6.0320). </a:t>
            </a:r>
            <a:endParaRPr lang="en-US" altLang="en-US" sz="1000" dirty="0">
              <a:latin typeface="Times" pitchFamily="2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BC4C7F64-66AD-8649-8BB3-5FD38A52E7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9405913"/>
              </p:ext>
            </p:extLst>
          </p:nvPr>
        </p:nvGraphicFramePr>
        <p:xfrm>
          <a:off x="388937" y="1070511"/>
          <a:ext cx="5562600" cy="51816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82233">
                  <a:extLst>
                    <a:ext uri="{9D8B030D-6E8A-4147-A177-3AD203B41FA5}">
                      <a16:colId xmlns:a16="http://schemas.microsoft.com/office/drawing/2014/main" val="1280105822"/>
                    </a:ext>
                  </a:extLst>
                </a:gridCol>
                <a:gridCol w="1594884">
                  <a:extLst>
                    <a:ext uri="{9D8B030D-6E8A-4147-A177-3AD203B41FA5}">
                      <a16:colId xmlns:a16="http://schemas.microsoft.com/office/drawing/2014/main" val="2134023344"/>
                    </a:ext>
                  </a:extLst>
                </a:gridCol>
                <a:gridCol w="1116418">
                  <a:extLst>
                    <a:ext uri="{9D8B030D-6E8A-4147-A177-3AD203B41FA5}">
                      <a16:colId xmlns:a16="http://schemas.microsoft.com/office/drawing/2014/main" val="256194836"/>
                    </a:ext>
                  </a:extLst>
                </a:gridCol>
                <a:gridCol w="1469065">
                  <a:extLst>
                    <a:ext uri="{9D8B030D-6E8A-4147-A177-3AD203B41FA5}">
                      <a16:colId xmlns:a16="http://schemas.microsoft.com/office/drawing/2014/main" val="3068592677"/>
                    </a:ext>
                  </a:extLst>
                </a:gridCol>
              </a:tblGrid>
              <a:tr h="36132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35433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35433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Line number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indent="-17145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17145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ddPCR nptII copy #</a:t>
                      </a:r>
                      <a:r>
                        <a:rPr lang="en-US" sz="10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66675" indent="-11430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66675" indent="-11430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66675" indent="-11430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  Line number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indent="-1257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 </a:t>
                      </a:r>
                    </a:p>
                    <a:p>
                      <a:pPr marL="0" marR="0" indent="-1257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</a:p>
                    <a:p>
                      <a:pPr marL="0" marR="0" indent="-1257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 ddPCR nptII copy #</a:t>
                      </a:r>
                      <a:r>
                        <a:rPr lang="en-US" sz="10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703181001"/>
                  </a:ext>
                </a:extLst>
              </a:tr>
              <a:tr h="9185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182271564"/>
                  </a:ext>
                </a:extLst>
              </a:tr>
              <a:tr h="9185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3156642800"/>
                  </a:ext>
                </a:extLst>
              </a:tr>
              <a:tr h="9185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0226505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4472952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509695753"/>
                  </a:ext>
                </a:extLst>
              </a:tr>
              <a:tr h="12044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3793289295"/>
                  </a:ext>
                </a:extLst>
              </a:tr>
              <a:tr h="1445308">
                <a:tc>
                  <a:txBody>
                    <a:bodyPr/>
                    <a:lstStyle/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1-1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1-2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1-3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1-4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6-3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6-7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6-8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6-9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7-1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7-2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7-4</a:t>
                      </a:r>
                    </a:p>
                    <a:p>
                      <a:pPr marL="0" marR="0" indent="1143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Gp-7-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7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6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4 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89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14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9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9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2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10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4 ± 0.0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1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1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1-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1-8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4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4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4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4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5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5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5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8p-5-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4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8 ± 0.08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9 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0 ± 0.0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.34 ± 0.1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5.07 ± 0.1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.02 ± 0.2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5.85 ± 0.4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4 ± 0.90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2 ± 0.0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3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80 ± 0.0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171783215"/>
                  </a:ext>
                </a:extLst>
              </a:tr>
              <a:tr h="120442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 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1829924016"/>
                  </a:ext>
                </a:extLst>
              </a:tr>
              <a:tr h="1445308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1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1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1-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1-7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2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2-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2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2-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3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3-4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3-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35Sp -3-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5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1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3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04 ± 0.08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0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97 ± 0.15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0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3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92 ± 0.0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88 ± 0.06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1.89 ± 0.13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2.07 ± 0.1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WT-1-1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WT-1-2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WT-1-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02 ± 0.00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03 ±0.00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0.01 ± 0.0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Times New Roman" panose="02020603050405020304" pitchFamily="18" charset="0"/>
                      </a:endParaRPr>
                    </a:p>
                  </a:txBody>
                  <a:tcPr marL="37329" marR="37329" marT="0" marB="0"/>
                </a:tc>
                <a:extLst>
                  <a:ext uri="{0D108BD9-81ED-4DB2-BD59-A6C34878D82A}">
                    <a16:rowId xmlns:a16="http://schemas.microsoft.com/office/drawing/2014/main" val="5358703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289601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EA0146D-076E-EF4D-B813-68B26CA52795}"/>
              </a:ext>
            </a:extLst>
          </p:cNvPr>
          <p:cNvSpPr/>
          <p:nvPr/>
        </p:nvSpPr>
        <p:spPr>
          <a:xfrm>
            <a:off x="291771" y="217141"/>
            <a:ext cx="5486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" pitchFamily="2" charset="0"/>
                <a:cs typeface="Times New Roman" panose="02020603050405020304" pitchFamily="18" charset="0"/>
              </a:rPr>
              <a:t>Additional file 2: Table S2. </a:t>
            </a:r>
            <a:r>
              <a:rPr lang="en-US" sz="1200" b="1" dirty="0" err="1">
                <a:latin typeface="Times" pitchFamily="2" charset="0"/>
              </a:rPr>
              <a:t>ddPCR</a:t>
            </a:r>
            <a:r>
              <a:rPr lang="en-US" sz="1200" b="1" dirty="0">
                <a:latin typeface="Times" pitchFamily="2" charset="0"/>
              </a:rPr>
              <a:t> primers and probe for reference and </a:t>
            </a:r>
          </a:p>
          <a:p>
            <a:r>
              <a:rPr lang="en-US" sz="1200" b="1" dirty="0">
                <a:latin typeface="Times" pitchFamily="2" charset="0"/>
              </a:rPr>
              <a:t>transgene detection</a:t>
            </a:r>
            <a:endParaRPr lang="en-US" sz="1200" b="1" dirty="0"/>
          </a:p>
          <a:p>
            <a:r>
              <a:rPr lang="en-US" sz="1200" b="1" dirty="0">
                <a:latin typeface="Times" pitchFamily="2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" pitchFamily="2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ABA37A4-E4A2-134F-8F21-2EF05A344BDA}"/>
              </a:ext>
            </a:extLst>
          </p:cNvPr>
          <p:cNvGraphicFramePr>
            <a:graphicFrameLocks noGrp="1"/>
          </p:cNvGraphicFramePr>
          <p:nvPr/>
        </p:nvGraphicFramePr>
        <p:xfrm>
          <a:off x="291771" y="858044"/>
          <a:ext cx="5638799" cy="255651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8592">
                  <a:extLst>
                    <a:ext uri="{9D8B030D-6E8A-4147-A177-3AD203B41FA5}">
                      <a16:colId xmlns:a16="http://schemas.microsoft.com/office/drawing/2014/main" val="2813071062"/>
                    </a:ext>
                  </a:extLst>
                </a:gridCol>
                <a:gridCol w="636808">
                  <a:extLst>
                    <a:ext uri="{9D8B030D-6E8A-4147-A177-3AD203B41FA5}">
                      <a16:colId xmlns:a16="http://schemas.microsoft.com/office/drawing/2014/main" val="790036220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3417912590"/>
                    </a:ext>
                  </a:extLst>
                </a:gridCol>
                <a:gridCol w="1447799">
                  <a:extLst>
                    <a:ext uri="{9D8B030D-6E8A-4147-A177-3AD203B41FA5}">
                      <a16:colId xmlns:a16="http://schemas.microsoft.com/office/drawing/2014/main" val="3603803138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139475465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8935079"/>
                    </a:ext>
                  </a:extLst>
                </a:gridCol>
              </a:tblGrid>
              <a:tr h="596223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ene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rime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rimer sequence 5′-3′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robe sequence</a:t>
                      </a:r>
                      <a:r>
                        <a:rPr lang="en-US" sz="11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 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5′-3′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mplicon (bp)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emp</a:t>
                      </a:r>
                      <a:r>
                        <a:rPr lang="en-US" sz="11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(°C)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extLst>
                  <a:ext uri="{0D108BD9-81ED-4DB2-BD59-A6C34878D82A}">
                    <a16:rowId xmlns:a16="http://schemas.microsoft.com/office/drawing/2014/main" val="3542574932"/>
                  </a:ext>
                </a:extLst>
              </a:tr>
              <a:tr h="596223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omato SlSYS</a:t>
                      </a: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84800</a:t>
                      </a:r>
                      <a:r>
                        <a:rPr lang="en-US" sz="11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o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caatatcaagagccccgt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gcaacatccttctttcttctcgtg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9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60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extLst>
                  <a:ext uri="{0D108BD9-81ED-4DB2-BD59-A6C34878D82A}">
                    <a16:rowId xmlns:a16="http://schemas.microsoft.com/office/drawing/2014/main" val="3700551321"/>
                  </a:ext>
                </a:extLst>
              </a:tr>
              <a:tr h="31859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Rev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tgtgtgctaagcgctc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9906712"/>
                  </a:ext>
                </a:extLst>
              </a:tr>
              <a:tr h="277626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nptII KT992772</a:t>
                      </a:r>
                      <a:r>
                        <a:rPr lang="en-US" sz="1100" baseline="300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or 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tgccgaatatcatggtgg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ggaccggacggggcggt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74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60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extLst>
                  <a:ext uri="{0D108BD9-81ED-4DB2-BD59-A6C34878D82A}">
                    <a16:rowId xmlns:a16="http://schemas.microsoft.com/office/drawing/2014/main" val="3942814770"/>
                  </a:ext>
                </a:extLst>
              </a:tr>
              <a:tr h="63719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Rev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agcaatatcacgggtagc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68" marR="65168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9023706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DBD592CC-2C70-5345-A928-6B604E2878D2}"/>
              </a:ext>
            </a:extLst>
          </p:cNvPr>
          <p:cNvSpPr/>
          <p:nvPr/>
        </p:nvSpPr>
        <p:spPr>
          <a:xfrm>
            <a:off x="291771" y="3594755"/>
            <a:ext cx="5638798" cy="10191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aseline="300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1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GenBank</a:t>
            </a:r>
            <a:r>
              <a:rPr lang="en-US" sz="11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ccession of the target sequence.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aseline="300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1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en-US" sz="11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reference gene </a:t>
            </a:r>
            <a:r>
              <a:rPr lang="en-US" sz="11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lSYS</a:t>
            </a:r>
            <a:r>
              <a:rPr lang="en-US" sz="11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mplicons were detected using FAM™-labeled probes, while the transgene </a:t>
            </a:r>
            <a:r>
              <a:rPr lang="en-US" sz="11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ptII</a:t>
            </a:r>
            <a:r>
              <a:rPr lang="en-US" sz="11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mplicons were detected with HEX™-labeled probes</a:t>
            </a:r>
            <a:r>
              <a:rPr lang="en-US" sz="1100" baseline="300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(Collier </a:t>
            </a:r>
            <a:r>
              <a:rPr lang="en-US" sz="1100" i="1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t al.,</a:t>
            </a:r>
            <a:r>
              <a:rPr lang="en-US" sz="11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2017)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aseline="300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100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rimer</a:t>
            </a:r>
            <a:r>
              <a:rPr lang="en-US" sz="1100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nnealing temperature used for amplification.</a:t>
            </a:r>
            <a:endParaRPr lang="en-US" sz="11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5237806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597</TotalTime>
  <Words>760</Words>
  <Application>Microsoft Macintosh PowerPoint</Application>
  <PresentationFormat>Custom</PresentationFormat>
  <Paragraphs>29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Times</vt:lpstr>
      <vt:lpstr>Default Design</vt:lpstr>
      <vt:lpstr>PowerPoint Presentation</vt:lpstr>
      <vt:lpstr>PowerPoint Presentation</vt:lpstr>
      <vt:lpstr>PowerPoint Presentation</vt:lpstr>
    </vt:vector>
  </TitlesOfParts>
  <Company>USDA, ARS, WRRC, Albany C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thilmony</dc:creator>
  <cp:lastModifiedBy>Thomson, James - ARS</cp:lastModifiedBy>
  <cp:revision>1259</cp:revision>
  <dcterms:created xsi:type="dcterms:W3CDTF">2013-03-19T23:20:18Z</dcterms:created>
  <dcterms:modified xsi:type="dcterms:W3CDTF">2020-07-06T22:17:55Z</dcterms:modified>
</cp:coreProperties>
</file>